
<file path=[Content_Types].xml><?xml version="1.0" encoding="utf-8"?>
<Types xmlns="http://schemas.openxmlformats.org/package/2006/content-types">
  <Default Extension="emf" ContentType="image/x-emf"/>
  <Override PartName="/docProps/core.xml" ContentType="application/vnd.openxmlformats-package.core-properties+xml"/>
  <Override PartName="/ppt/slideLayouts/slideLayout6.xml" ContentType="application/vnd.openxmlformats-officedocument.presentationml.slideLayout+xml"/>
  <Default Extension="rels" ContentType="application/vnd.openxmlformats-package.relationships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Default Extension="png" ContentType="image/png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60" r:id="rId1"/>
  </p:sldMasterIdLst>
  <p:sldIdLst>
    <p:sldId id="256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a="http://schemas.openxmlformats.org/drawingml/2006/main" xmlns:r="http://schemas.openxmlformats.org/officeDocument/2006/relationships" xmlns:p="http://schemas.openxmlformats.org/presentationml/2006/main" xmlns:p15="http://schemas.microsoft.com/office/powerpoint/2012/main" xmlns:mv="urn:schemas-microsoft-com:mac:vml" xmlns:mc="http://schemas.openxmlformats.org/markup-compatibility/2006">
        <p15:guide id="2" pos="3067" userDrawn="1">
          <p15:clr>
            <a:srgbClr val="A4A3A4"/>
          </p15:clr>
        </p15:guide>
        <p15:guide id="3" orient="horz" pos="265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extLst>
    <p:ext uri="{E76CE94A-603C-4142-B9EB-6D1370010A27}">
      <p14:discardImageEditData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0"/>
    </p:ext>
    <p:ext uri="{D31A062A-798A-4329-ABDD-BBA856620510}">
      <p14:defaultImageDpi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2767"/>
    </p:ext>
    <p:ext uri="{FD5EFAAD-0ECE-453E-9831-46B23BE46B34}">
      <p15:chartTrackingRefBased xmlns="" xmlns:a="http://schemas.openxmlformats.org/drawingml/2006/main" xmlns:r="http://schemas.openxmlformats.org/officeDocument/2006/relationships" xmlns:p="http://schemas.openxmlformats.org/presentationml/2006/main" xmlns:p15="http://schemas.microsoft.com/office/powerpoint/2012/main" xmlns:mv="urn:schemas-microsoft-com:mac:vml" xmlns:mc="http://schemas.openxmlformats.org/markup-compatibility/2006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 horzBarState="maximized">
    <p:restoredLeft sz="15614"/>
    <p:restoredTop sz="94674"/>
  </p:normalViewPr>
  <p:slideViewPr>
    <p:cSldViewPr snapToGrid="0" snapToObjects="1" showGuides="1">
      <p:cViewPr>
        <p:scale>
          <a:sx n="50" d="100"/>
          <a:sy n="50" d="100"/>
        </p:scale>
        <p:origin x="-2280" y="-376"/>
      </p:cViewPr>
      <p:guideLst>
        <p:guide orient="horz" pos="2653"/>
        <p:guide pos="306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8209708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9464378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6133842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4294807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7750442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5244153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1991612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5670867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5026182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4789972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1444508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5569191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em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5" name="Grouper 154"/>
          <p:cNvGrpSpPr/>
          <p:nvPr/>
        </p:nvGrpSpPr>
        <p:grpSpPr>
          <a:xfrm>
            <a:off x="64248" y="305407"/>
            <a:ext cx="6641352" cy="8420874"/>
            <a:chOff x="64248" y="305407"/>
            <a:chExt cx="6641352" cy="8420874"/>
          </a:xfrm>
        </p:grpSpPr>
        <p:grpSp>
          <p:nvGrpSpPr>
            <p:cNvPr id="120" name="Groupe 119">
              <a:extLst>
                <a:ext uri="{FF2B5EF4-FFF2-40B4-BE49-F238E27FC236}">
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7D54E35-B673-4242-9D13-A0682D8DE8A3}"/>
                </a:ext>
              </a:extLst>
            </p:cNvPr>
            <p:cNvGrpSpPr/>
            <p:nvPr/>
          </p:nvGrpSpPr>
          <p:grpSpPr>
            <a:xfrm>
              <a:off x="4514029" y="3541905"/>
              <a:ext cx="468410" cy="215444"/>
              <a:chOff x="-18613" y="3542432"/>
              <a:chExt cx="468410" cy="215444"/>
            </a:xfrm>
          </p:grpSpPr>
          <p:sp>
            <p:nvSpPr>
              <p:cNvPr id="121" name="Rectangle 120">
                <a:extLst>
                  <a:ext uri="{FF2B5EF4-FFF2-40B4-BE49-F238E27FC236}">
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28D145F-9393-904D-BDF7-A0AFEB0E6500}"/>
                  </a:ext>
                </a:extLst>
              </p:cNvPr>
              <p:cNvSpPr/>
              <p:nvPr/>
            </p:nvSpPr>
            <p:spPr>
              <a:xfrm>
                <a:off x="-18613" y="3542432"/>
                <a:ext cx="41549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8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000</a:t>
                </a:r>
                <a:endParaRPr lang="fr-FR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22" name="Groupe 121">
                <a:extLst>
                  <a:ext uri="{FF2B5EF4-FFF2-40B4-BE49-F238E27FC236}">
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F06DE6C-CD16-124F-8B85-53FD0D997695}"/>
                  </a:ext>
                </a:extLst>
              </p:cNvPr>
              <p:cNvGrpSpPr/>
              <p:nvPr/>
            </p:nvGrpSpPr>
            <p:grpSpPr>
              <a:xfrm>
                <a:off x="309969" y="3663002"/>
                <a:ext cx="139828" cy="49020"/>
                <a:chOff x="309969" y="3663002"/>
                <a:chExt cx="139828" cy="49020"/>
              </a:xfrm>
            </p:grpSpPr>
            <p:cxnSp>
              <p:nvCxnSpPr>
                <p:cNvPr id="123" name="Connecteur droit avec flèche 122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E34598E-AD18-294A-BE63-9F614524CEE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341797" y="3711293"/>
                  <a:ext cx="108000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headEnd type="none"/>
                  <a:tailEnd type="none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4" name="Connecteur droit avec flèche 123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FA763B3-2D9A-7F47-820E-A6D43A0FEDC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309969" y="3663002"/>
                  <a:ext cx="36000" cy="4902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headEnd type="none"/>
                  <a:tailEnd type="none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25" name="Groupe 124">
              <a:extLst>
                <a:ext uri="{FF2B5EF4-FFF2-40B4-BE49-F238E27FC236}">
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C5622E8-7B36-B943-AD29-D60A9AD353A8}"/>
                </a:ext>
              </a:extLst>
            </p:cNvPr>
            <p:cNvGrpSpPr/>
            <p:nvPr/>
          </p:nvGrpSpPr>
          <p:grpSpPr>
            <a:xfrm>
              <a:off x="4514029" y="3417864"/>
              <a:ext cx="468410" cy="215444"/>
              <a:chOff x="-18613" y="3418391"/>
              <a:chExt cx="468410" cy="215444"/>
            </a:xfrm>
          </p:grpSpPr>
          <p:cxnSp>
            <p:nvCxnSpPr>
              <p:cNvPr id="126" name="Connecteur droit avec flèche 125">
                <a:extLst>
                  <a:ext uri="{FF2B5EF4-FFF2-40B4-BE49-F238E27FC236}">
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8C5E694-06B4-1747-84B1-99C2D102595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41797" y="3537628"/>
                <a:ext cx="10800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none"/>
                <a:tailEnd type="none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7" name="Rectangle 126">
                <a:extLst>
                  <a:ext uri="{FF2B5EF4-FFF2-40B4-BE49-F238E27FC236}">
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BA6ED3B-F199-E548-9BB4-29A05DE8F088}"/>
                  </a:ext>
                </a:extLst>
              </p:cNvPr>
              <p:cNvSpPr/>
              <p:nvPr/>
            </p:nvSpPr>
            <p:spPr>
              <a:xfrm>
                <a:off x="-18613" y="3418391"/>
                <a:ext cx="41549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8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500</a:t>
                </a:r>
                <a:endParaRPr lang="fr-FR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28" name="Groupe 127">
              <a:extLst>
                <a:ext uri="{FF2B5EF4-FFF2-40B4-BE49-F238E27FC236}">
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DD30535-7D2A-B643-9AFC-F7EB7D48E73A}"/>
                </a:ext>
              </a:extLst>
            </p:cNvPr>
            <p:cNvGrpSpPr/>
            <p:nvPr/>
          </p:nvGrpSpPr>
          <p:grpSpPr>
            <a:xfrm>
              <a:off x="4514029" y="3286735"/>
              <a:ext cx="468410" cy="215444"/>
              <a:chOff x="-18613" y="3287262"/>
              <a:chExt cx="468410" cy="215444"/>
            </a:xfrm>
          </p:grpSpPr>
          <p:cxnSp>
            <p:nvCxnSpPr>
              <p:cNvPr id="129" name="Connecteur droit avec flèche 128">
                <a:extLst>
                  <a:ext uri="{FF2B5EF4-FFF2-40B4-BE49-F238E27FC236}">
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F9849FA-D66A-2342-B783-FD12BEFA5DE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41797" y="3385227"/>
                <a:ext cx="10800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none"/>
                <a:tailEnd type="none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0" name="Rectangle 129">
                <a:extLst>
                  <a:ext uri="{FF2B5EF4-FFF2-40B4-BE49-F238E27FC236}">
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0298599-6620-A149-B1D2-5FBCDBC5475C}"/>
                  </a:ext>
                </a:extLst>
              </p:cNvPr>
              <p:cNvSpPr/>
              <p:nvPr/>
            </p:nvSpPr>
            <p:spPr>
              <a:xfrm>
                <a:off x="-18613" y="3287262"/>
                <a:ext cx="41549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8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000</a:t>
                </a:r>
                <a:endParaRPr lang="fr-FR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31" name="Groupe 130">
              <a:extLst>
                <a:ext uri="{FF2B5EF4-FFF2-40B4-BE49-F238E27FC236}">
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02AFE3F-1884-7040-A179-BA6841508341}"/>
                </a:ext>
              </a:extLst>
            </p:cNvPr>
            <p:cNvGrpSpPr/>
            <p:nvPr/>
          </p:nvGrpSpPr>
          <p:grpSpPr>
            <a:xfrm>
              <a:off x="4514029" y="3199519"/>
              <a:ext cx="468410" cy="215444"/>
              <a:chOff x="-18613" y="3170310"/>
              <a:chExt cx="468410" cy="215444"/>
            </a:xfrm>
          </p:grpSpPr>
          <p:cxnSp>
            <p:nvCxnSpPr>
              <p:cNvPr id="132" name="Connecteur droit avec flèche 131">
                <a:extLst>
                  <a:ext uri="{FF2B5EF4-FFF2-40B4-BE49-F238E27FC236}">
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B74B232-C3E7-8346-9A0B-C8A60734A07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41797" y="3282442"/>
                <a:ext cx="10800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none"/>
                <a:tailEnd type="none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3" name="Rectangle 132">
                <a:extLst>
                  <a:ext uri="{FF2B5EF4-FFF2-40B4-BE49-F238E27FC236}">
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A2682AB-7FC6-7041-B7BF-B5E1914EA2AB}"/>
                  </a:ext>
                </a:extLst>
              </p:cNvPr>
              <p:cNvSpPr/>
              <p:nvPr/>
            </p:nvSpPr>
            <p:spPr>
              <a:xfrm>
                <a:off x="-18613" y="3170310"/>
                <a:ext cx="41549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8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500</a:t>
                </a:r>
                <a:endParaRPr lang="fr-FR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8" name="Groupe 67">
              <a:extLst>
                <a:ext uri="{FF2B5EF4-FFF2-40B4-BE49-F238E27FC236}">
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8E032B1-842B-2942-8258-353A6E7D81D2}"/>
                </a:ext>
              </a:extLst>
            </p:cNvPr>
            <p:cNvGrpSpPr/>
            <p:nvPr/>
          </p:nvGrpSpPr>
          <p:grpSpPr>
            <a:xfrm>
              <a:off x="64248" y="305407"/>
              <a:ext cx="6641352" cy="8420874"/>
              <a:chOff x="64248" y="305407"/>
              <a:chExt cx="6641352" cy="8420874"/>
            </a:xfrm>
          </p:grpSpPr>
          <p:grpSp>
            <p:nvGrpSpPr>
              <p:cNvPr id="92" name="Groupe 91">
                <a:extLst>
                  <a:ext uri="{FF2B5EF4-FFF2-40B4-BE49-F238E27FC236}">
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48587A0-5905-E344-8885-25A2385DE2BB}"/>
                  </a:ext>
                </a:extLst>
              </p:cNvPr>
              <p:cNvGrpSpPr/>
              <p:nvPr/>
            </p:nvGrpSpPr>
            <p:grpSpPr>
              <a:xfrm>
                <a:off x="295960" y="305407"/>
                <a:ext cx="4374679" cy="1542022"/>
                <a:chOff x="299907" y="278111"/>
                <a:chExt cx="4374679" cy="1542022"/>
              </a:xfrm>
            </p:grpSpPr>
            <p:grpSp>
              <p:nvGrpSpPr>
                <p:cNvPr id="53" name="Groupe 52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78AEA9C-B868-3F46-9EEF-A6C9D8E85D3A}"/>
                    </a:ext>
                  </a:extLst>
                </p:cNvPr>
                <p:cNvGrpSpPr/>
                <p:nvPr/>
              </p:nvGrpSpPr>
              <p:grpSpPr>
                <a:xfrm>
                  <a:off x="1840011" y="478166"/>
                  <a:ext cx="2834575" cy="1341967"/>
                  <a:chOff x="1831699" y="982816"/>
                  <a:chExt cx="2834575" cy="1341967"/>
                </a:xfrm>
              </p:grpSpPr>
              <p:cxnSp>
                <p:nvCxnSpPr>
                  <p:cNvPr id="4" name="Straight Connector 10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238ADF0-5D2A-EE4E-A464-DE64EB668F82}"/>
                      </a:ext>
                    </a:extLst>
                  </p:cNvPr>
                  <p:cNvCxnSpPr>
                    <a:cxnSpLocks noChangeAspect="1"/>
                  </p:cNvCxnSpPr>
                  <p:nvPr/>
                </p:nvCxnSpPr>
                <p:spPr>
                  <a:xfrm flipV="1">
                    <a:off x="1890336" y="1604094"/>
                    <a:ext cx="2736000" cy="10014"/>
                  </a:xfrm>
                  <a:prstGeom prst="line">
                    <a:avLst/>
                  </a:prstGeom>
                  <a:ln>
                    <a:headEnd type="none" w="med" len="med"/>
                    <a:tailEnd type="none" w="med" len="med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" name="Down Arrow 12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7662D05-0967-0D47-A206-51E7C02AB264}"/>
                      </a:ext>
                    </a:extLst>
                  </p:cNvPr>
                  <p:cNvSpPr>
                    <a:spLocks/>
                  </p:cNvSpPr>
                  <p:nvPr/>
                </p:nvSpPr>
                <p:spPr>
                  <a:xfrm rot="16200000">
                    <a:off x="4261048" y="1449003"/>
                    <a:ext cx="215999" cy="327189"/>
                  </a:xfrm>
                  <a:prstGeom prst="downArrow">
                    <a:avLst>
                      <a:gd name="adj1" fmla="val 56250"/>
                      <a:gd name="adj2" fmla="val 50000"/>
                    </a:avLst>
                  </a:prstGeom>
                  <a:solidFill>
                    <a:srgbClr val="0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vert="vert270" rtlCol="0" anchor="ctr"/>
                  <a:lstStyle/>
                  <a:p>
                    <a:pPr algn="ctr"/>
                    <a:endParaRPr lang="en-US" sz="12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" name="Down Arrow 13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A1FB08A-9649-7641-9685-EB1A6B4668DF}"/>
                      </a:ext>
                    </a:extLst>
                  </p:cNvPr>
                  <p:cNvSpPr>
                    <a:spLocks/>
                  </p:cNvSpPr>
                  <p:nvPr/>
                </p:nvSpPr>
                <p:spPr>
                  <a:xfrm rot="5400000">
                    <a:off x="3414842" y="1479172"/>
                    <a:ext cx="215999" cy="251998"/>
                  </a:xfrm>
                  <a:prstGeom prst="downArrow">
                    <a:avLst/>
                  </a:prstGeom>
                  <a:solidFill>
                    <a:srgbClr val="0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vert="vert270" rtlCol="0" anchor="ctr"/>
                  <a:lstStyle/>
                  <a:p>
                    <a:pPr algn="ctr"/>
                    <a:endParaRPr lang="en-US" sz="12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" name="Down Arrow 1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1B76F58-635A-B449-813B-AC539E25A753}"/>
                      </a:ext>
                    </a:extLst>
                  </p:cNvPr>
                  <p:cNvSpPr>
                    <a:spLocks/>
                  </p:cNvSpPr>
                  <p:nvPr/>
                </p:nvSpPr>
                <p:spPr>
                  <a:xfrm rot="5400000">
                    <a:off x="3057124" y="1374884"/>
                    <a:ext cx="223426" cy="468000"/>
                  </a:xfrm>
                  <a:prstGeom prst="downArrow">
                    <a:avLst/>
                  </a:prstGeom>
                  <a:solidFill>
                    <a:srgbClr val="00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vert="vert270" rtlCol="0" anchor="ctr"/>
                  <a:lstStyle/>
                  <a:p>
                    <a:pPr algn="ctr"/>
                    <a:endParaRPr lang="en-US" sz="1200" b="1">
                      <a:solidFill>
                        <a:srgbClr val="FFFF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" name="Down Arrow 1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19C350F-2D23-8A4D-B0AA-C8D2C3A95950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5400000">
                    <a:off x="2111630" y="1364060"/>
                    <a:ext cx="223424" cy="489558"/>
                  </a:xfrm>
                  <a:prstGeom prst="downArrow">
                    <a:avLst/>
                  </a:prstGeom>
                  <a:solidFill>
                    <a:schemeClr val="tx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vert="vert270" rtlCol="0" anchor="ctr"/>
                  <a:lstStyle/>
                  <a:p>
                    <a:pPr algn="ctr"/>
                    <a:endParaRPr lang="en-US" sz="1200" b="1" i="1">
                      <a:solidFill>
                        <a:srgbClr val="FFFF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grpSp>
                <p:nvGrpSpPr>
                  <p:cNvPr id="9" name="Grouper 51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206E9CF-45AA-474D-A4B7-136A7A14CECE}"/>
                      </a:ext>
                    </a:extLst>
                  </p:cNvPr>
                  <p:cNvGrpSpPr/>
                  <p:nvPr/>
                </p:nvGrpSpPr>
                <p:grpSpPr>
                  <a:xfrm>
                    <a:off x="1831699" y="982816"/>
                    <a:ext cx="783286" cy="477054"/>
                    <a:chOff x="389468" y="1000428"/>
                    <a:chExt cx="783286" cy="477054"/>
                  </a:xfrm>
                </p:grpSpPr>
                <p:sp>
                  <p:nvSpPr>
                    <p:cNvPr id="10" name="TextBox 22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E59F961-E6A9-BC48-8D81-5DDB7FE6422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89468" y="1308205"/>
                      <a:ext cx="783286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 anchor="t" anchorCtr="0">
                      <a:spAutoFit/>
                    </a:bodyPr>
                    <a:lstStyle/>
                    <a:p>
                      <a:pPr algn="ctr"/>
                      <a:r>
                        <a:rPr lang="en-US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s Kinase</a:t>
                      </a:r>
                    </a:p>
                  </p:txBody>
                </p:sp>
                <p:sp>
                  <p:nvSpPr>
                    <p:cNvPr id="11" name="TextBox 20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8E5DD6B-4E51-FF4A-83A3-7E69C0BABC7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83885" y="1000428"/>
                      <a:ext cx="594453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MLP</a:t>
                      </a:r>
                    </a:p>
                    <a:p>
                      <a:pPr algn="ctr"/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10140</a:t>
                      </a:r>
                    </a:p>
                  </p:txBody>
                </p:sp>
              </p:grpSp>
              <p:grpSp>
                <p:nvGrpSpPr>
                  <p:cNvPr id="12" name="Grouper 52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FD896E1-B401-3748-9DB9-8A216D49C30A}"/>
                      </a:ext>
                    </a:extLst>
                  </p:cNvPr>
                  <p:cNvGrpSpPr/>
                  <p:nvPr/>
                </p:nvGrpSpPr>
                <p:grpSpPr>
                  <a:xfrm>
                    <a:off x="2778895" y="982816"/>
                    <a:ext cx="497639" cy="468587"/>
                    <a:chOff x="1421334" y="1000428"/>
                    <a:chExt cx="497639" cy="468587"/>
                  </a:xfrm>
                </p:grpSpPr>
                <p:sp>
                  <p:nvSpPr>
                    <p:cNvPr id="13" name="TextBox 23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3C4D056-344F-404B-B797-86232494965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474821" y="1299738"/>
                      <a:ext cx="390664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="1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atE</a:t>
                      </a:r>
                      <a:endParaRPr lang="en-US" sz="1100" b="1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4" name="TextBox 20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90D51D4-C5BA-5048-8AD6-22CB9DEBB6A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421334" y="1000428"/>
                      <a:ext cx="497639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MLP</a:t>
                      </a:r>
                    </a:p>
                    <a:p>
                      <a:pPr algn="ctr"/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10145</a:t>
                      </a:r>
                    </a:p>
                  </p:txBody>
                </p:sp>
              </p:grpSp>
              <p:grpSp>
                <p:nvGrpSpPr>
                  <p:cNvPr id="15" name="Grouper 5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15325D7-89E5-454F-BC6B-3D7798C2D620}"/>
                      </a:ext>
                    </a:extLst>
                  </p:cNvPr>
                  <p:cNvGrpSpPr/>
                  <p:nvPr/>
                </p:nvGrpSpPr>
                <p:grpSpPr>
                  <a:xfrm>
                    <a:off x="4071821" y="982816"/>
                    <a:ext cx="594453" cy="468587"/>
                    <a:chOff x="2663458" y="1000428"/>
                    <a:chExt cx="594453" cy="468587"/>
                  </a:xfrm>
                </p:grpSpPr>
                <p:sp>
                  <p:nvSpPr>
                    <p:cNvPr id="16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D16B083-FB0D-5547-8C38-DB2DAFEBEB3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707083" y="1299738"/>
                      <a:ext cx="511540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1100" b="1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R</a:t>
                      </a:r>
                      <a:endParaRPr lang="en-US" sz="1100" b="1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7" name="TextBox 20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75B731B-029D-494E-AE51-77F18E3AD27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663458" y="1000428"/>
                      <a:ext cx="594453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MLP</a:t>
                      </a:r>
                    </a:p>
                    <a:p>
                      <a:pPr algn="ctr"/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10155</a:t>
                      </a:r>
                    </a:p>
                  </p:txBody>
                </p:sp>
              </p:grpSp>
              <p:sp>
                <p:nvSpPr>
                  <p:cNvPr id="18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961DAC9-C455-C44C-AE08-55EDD1268A4A}"/>
                      </a:ext>
                    </a:extLst>
                  </p:cNvPr>
                  <p:cNvSpPr txBox="1"/>
                  <p:nvPr/>
                </p:nvSpPr>
                <p:spPr>
                  <a:xfrm>
                    <a:off x="3750397" y="1416021"/>
                    <a:ext cx="347368" cy="13849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91</a:t>
                    </a:r>
                  </a:p>
                </p:txBody>
              </p:sp>
              <p:sp>
                <p:nvSpPr>
                  <p:cNvPr id="19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A7522F6-1D07-FA4C-A322-051D32A76710}"/>
                      </a:ext>
                    </a:extLst>
                  </p:cNvPr>
                  <p:cNvSpPr txBox="1"/>
                  <p:nvPr/>
                </p:nvSpPr>
                <p:spPr>
                  <a:xfrm>
                    <a:off x="2528009" y="1435348"/>
                    <a:ext cx="378886" cy="13849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04</a:t>
                    </a:r>
                  </a:p>
                </p:txBody>
              </p:sp>
              <p:grpSp>
                <p:nvGrpSpPr>
                  <p:cNvPr id="21" name="Grouper 53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7672C73-E4AE-9248-843E-1C2717A0DA56}"/>
                      </a:ext>
                    </a:extLst>
                  </p:cNvPr>
                  <p:cNvGrpSpPr/>
                  <p:nvPr/>
                </p:nvGrpSpPr>
                <p:grpSpPr>
                  <a:xfrm>
                    <a:off x="3354169" y="982816"/>
                    <a:ext cx="534916" cy="468587"/>
                    <a:chOff x="1996608" y="1000428"/>
                    <a:chExt cx="534916" cy="468587"/>
                  </a:xfrm>
                </p:grpSpPr>
                <p:sp>
                  <p:nvSpPr>
                    <p:cNvPr id="22" name="TextBox 24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FF72D2A-C10B-E944-985C-4F5A0C03A5C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67026" y="1299738"/>
                      <a:ext cx="394081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1100" b="1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r>
                        <a:rPr lang="en-US" sz="1100" b="1" i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k</a:t>
                      </a:r>
                      <a:endParaRPr lang="en-US" sz="1100" b="1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3" name="TextBox 20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00BF287-828D-1444-B3C2-F752BB52B8E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996608" y="1000428"/>
                      <a:ext cx="534916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MLP</a:t>
                      </a:r>
                    </a:p>
                    <a:p>
                      <a:pPr algn="ctr"/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_10150</a:t>
                      </a:r>
                    </a:p>
                  </p:txBody>
                </p:sp>
              </p:grpSp>
              <p:sp>
                <p:nvSpPr>
                  <p:cNvPr id="25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4034987-C35B-8D44-90E0-7B29F2870E17}"/>
                      </a:ext>
                    </a:extLst>
                  </p:cNvPr>
                  <p:cNvSpPr txBox="1"/>
                  <p:nvPr/>
                </p:nvSpPr>
                <p:spPr>
                  <a:xfrm>
                    <a:off x="3261032" y="1750401"/>
                    <a:ext cx="299285" cy="24622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</a:p>
                  <a:p>
                    <a:pPr algn="ctr"/>
                    <a:r>
                      <a:rPr lang="en-US" sz="8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155)</a:t>
                    </a:r>
                  </a:p>
                </p:txBody>
              </p:sp>
              <p:cxnSp>
                <p:nvCxnSpPr>
                  <p:cNvPr id="26" name="Connecteur droit avec flèche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D4DE2C3-9D58-E349-B901-7F84BCF5BC0A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3229259" y="1743884"/>
                    <a:ext cx="395997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headEnd type="none"/>
                    <a:tailEnd type="none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9" name="Connecteur droit avec flèche 28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5858F72-73DE-0648-AF22-824C7CC03E26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3503141" y="2048446"/>
                    <a:ext cx="827998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headEnd type="none"/>
                    <a:tailEnd type="none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0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D62C5A0-79CD-2147-A500-D8DECD4FC28C}"/>
                      </a:ext>
                    </a:extLst>
                  </p:cNvPr>
                  <p:cNvSpPr txBox="1"/>
                  <p:nvPr/>
                </p:nvSpPr>
                <p:spPr>
                  <a:xfrm>
                    <a:off x="3767498" y="2078562"/>
                    <a:ext cx="299285" cy="24622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</a:t>
                    </a:r>
                  </a:p>
                  <a:p>
                    <a:pPr algn="ctr"/>
                    <a:r>
                      <a:rPr lang="en-US" sz="8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495)</a:t>
                    </a:r>
                  </a:p>
                </p:txBody>
              </p:sp>
              <p:cxnSp>
                <p:nvCxnSpPr>
                  <p:cNvPr id="31" name="Connecteur droit avec flèche 30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790A780-1447-2142-9EB3-05C1328116E7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2298272" y="1859819"/>
                    <a:ext cx="863998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headEnd type="none"/>
                    <a:tailEnd type="none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2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95D88FF-9CBF-124A-B9BB-D025FBB815D6}"/>
                      </a:ext>
                    </a:extLst>
                  </p:cNvPr>
                  <p:cNvSpPr txBox="1"/>
                  <p:nvPr/>
                </p:nvSpPr>
                <p:spPr>
                  <a:xfrm>
                    <a:off x="2580629" y="1902332"/>
                    <a:ext cx="299285" cy="246221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</a:t>
                    </a:r>
                  </a:p>
                  <a:p>
                    <a:pPr algn="ctr"/>
                    <a:r>
                      <a:rPr lang="en-US" sz="800" b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408)</a:t>
                    </a:r>
                  </a:p>
                </p:txBody>
              </p:sp>
            </p:grpSp>
            <p:sp>
              <p:nvSpPr>
                <p:cNvPr id="85" name="ZoneTexte 84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3034674-1E29-B544-BA8B-0AD88BFB41B6}"/>
                    </a:ext>
                  </a:extLst>
                </p:cNvPr>
                <p:cNvSpPr txBox="1"/>
                <p:nvPr/>
              </p:nvSpPr>
              <p:spPr>
                <a:xfrm>
                  <a:off x="299907" y="278111"/>
                  <a:ext cx="332142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1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</a:p>
              </p:txBody>
            </p:sp>
          </p:grpSp>
          <p:grpSp>
            <p:nvGrpSpPr>
              <p:cNvPr id="93" name="Groupe 92">
                <a:extLst>
                  <a:ext uri="{FF2B5EF4-FFF2-40B4-BE49-F238E27FC236}">
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4D7D264-6B95-6F4A-8AA0-588F04083AD4}"/>
                  </a:ext>
                </a:extLst>
              </p:cNvPr>
              <p:cNvGrpSpPr/>
              <p:nvPr/>
            </p:nvGrpSpPr>
            <p:grpSpPr>
              <a:xfrm>
                <a:off x="64248" y="2156024"/>
                <a:ext cx="6641352" cy="2242118"/>
                <a:chOff x="68195" y="2128728"/>
                <a:chExt cx="6641352" cy="2242118"/>
              </a:xfrm>
            </p:grpSpPr>
            <p:grpSp>
              <p:nvGrpSpPr>
                <p:cNvPr id="27" name="Groupe 26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A206726-8EF2-064B-BA4D-72C56DA969E0}"/>
                    </a:ext>
                  </a:extLst>
                </p:cNvPr>
                <p:cNvGrpSpPr/>
                <p:nvPr/>
              </p:nvGrpSpPr>
              <p:grpSpPr>
                <a:xfrm>
                  <a:off x="68195" y="2128728"/>
                  <a:ext cx="6641352" cy="2242118"/>
                  <a:chOff x="68195" y="2115080"/>
                  <a:chExt cx="6641352" cy="2242118"/>
                </a:xfrm>
              </p:grpSpPr>
              <p:grpSp>
                <p:nvGrpSpPr>
                  <p:cNvPr id="2" name="Groupe 1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E03FC6C-DAA4-6545-80B9-B04CEB58FFC3}"/>
                      </a:ext>
                    </a:extLst>
                  </p:cNvPr>
                  <p:cNvGrpSpPr/>
                  <p:nvPr/>
                </p:nvGrpSpPr>
                <p:grpSpPr>
                  <a:xfrm>
                    <a:off x="68195" y="2124597"/>
                    <a:ext cx="2193067" cy="2232601"/>
                    <a:chOff x="68195" y="2124597"/>
                    <a:chExt cx="2193067" cy="2232601"/>
                  </a:xfrm>
                </p:grpSpPr>
                <p:grpSp>
                  <p:nvGrpSpPr>
                    <p:cNvPr id="33" name="Grouper 3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566C009-2810-3B49-955B-2A0E1E8C4B79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533262" y="2124597"/>
                      <a:ext cx="1728000" cy="2232601"/>
                      <a:chOff x="669122" y="5451997"/>
                      <a:chExt cx="1728000" cy="2232601"/>
                    </a:xfrm>
                  </p:grpSpPr>
                  <p:sp>
                    <p:nvSpPr>
                      <p:cNvPr id="34" name="TextBox 25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51486AD-F5F1-B541-B930-0B0E0D82A2C6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178554" y="5933980"/>
                        <a:ext cx="417823" cy="15388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lIns="0" tIns="0" rIns="0" bIns="0" rtlCol="0">
                        <a:spAutoFit/>
                      </a:bodyPr>
                      <a:lstStyle/>
                      <a:p>
                        <a:pPr algn="ctr"/>
                        <a:r>
                          <a:rPr lang="en-US" sz="1000" b="1" dirty="0" err="1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gDNA</a:t>
                        </a:r>
                        <a:endParaRPr lang="en-US" sz="1000" b="1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35" name="TextBox 25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BCD1FF8-0532-9E43-8B79-399E895C32C8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283788" y="5451997"/>
                        <a:ext cx="841715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lIns="0" tIns="0" rIns="0" bIns="0" rtlCol="0">
                        <a:spAutoFit/>
                      </a:bodyPr>
                      <a:lstStyle/>
                      <a:p>
                        <a:pPr algn="ctr"/>
                        <a:r>
                          <a:rPr lang="en-US" sz="1200" b="1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</a:t>
                        </a:r>
                      </a:p>
                      <a:p>
                        <a:pPr algn="ctr"/>
                        <a:r>
                          <a:rPr lang="en-US" sz="1200" b="1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(408 </a:t>
                        </a:r>
                        <a:r>
                          <a:rPr lang="en-US" sz="1200" b="1" dirty="0" err="1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bp</a:t>
                        </a:r>
                        <a:r>
                          <a:rPr lang="en-US" sz="1200" b="1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)</a:t>
                        </a:r>
                      </a:p>
                    </p:txBody>
                  </p:sp>
                  <p:sp>
                    <p:nvSpPr>
                      <p:cNvPr id="36" name="TextBox 25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C239F94-B5CE-764A-BD29-A8794A00BA2C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583941" y="5933980"/>
                        <a:ext cx="391930" cy="15388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lIns="0" tIns="0" rIns="0" bIns="0" rtlCol="0">
                        <a:spAutoFit/>
                      </a:bodyPr>
                      <a:lstStyle/>
                      <a:p>
                        <a:pPr algn="ctr"/>
                        <a:r>
                          <a:rPr lang="en-US" sz="1000" b="1" dirty="0" err="1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cDNA</a:t>
                        </a:r>
                        <a:endParaRPr lang="en-US" sz="1000" b="1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37" name="TextBox 25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94CCD2A-DAB0-E148-AE68-3C1DCC2E1234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977503" y="5933980"/>
                        <a:ext cx="299285" cy="15388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lIns="0" tIns="0" rIns="0" bIns="0" rtlCol="0">
                        <a:spAutoFit/>
                      </a:bodyPr>
                      <a:lstStyle/>
                      <a:p>
                        <a:pPr algn="ctr"/>
                        <a:r>
                          <a:rPr lang="en-US" sz="1000" b="1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RNA</a:t>
                        </a:r>
                      </a:p>
                    </p:txBody>
                  </p:sp>
                  <p:sp>
                    <p:nvSpPr>
                      <p:cNvPr id="38" name="Parenthèse ouvrante 37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DBADED8-0847-1143-AFE6-5C314E7FF29A}"/>
                          </a:ext>
                        </a:extLst>
                      </p:cNvPr>
                      <p:cNvSpPr/>
                      <p:nvPr/>
                    </p:nvSpPr>
                    <p:spPr>
                      <a:xfrm rot="5400000">
                        <a:off x="1703569" y="5357776"/>
                        <a:ext cx="45719" cy="1040561"/>
                      </a:xfrm>
                      <a:prstGeom prst="leftBracket">
                        <a:avLst/>
                      </a:prstGeom>
                      <a:ln w="1905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fr-FR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pic>
                    <p:nvPicPr>
                      <p:cNvPr id="39" name="Image 38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8119E2D-30F5-1A4C-8CAB-00308C71FE8C}"/>
                          </a:ext>
                        </a:extLst>
                      </p:cNvPr>
                      <p:cNvPicPr>
                        <a:picLocks/>
                      </p:cNvPicPr>
                      <p:nvPr/>
                    </p:nvPicPr>
                    <p:blipFill>
                      <a:blip r:embed="rId2"/>
                      <a:stretch>
                        <a:fillRect/>
                      </a:stretch>
                    </p:blipFill>
                    <p:spPr>
                      <a:xfrm>
                        <a:off x="669122" y="6100598"/>
                        <a:ext cx="1728000" cy="1584000"/>
                      </a:xfrm>
                      <a:prstGeom prst="rect">
                        <a:avLst/>
                      </a:prstGeom>
                    </p:spPr>
                  </p:pic>
                </p:grpSp>
                <p:grpSp>
                  <p:nvGrpSpPr>
                    <p:cNvPr id="103" name="Groupe 102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A937384-D4E2-6D4D-B3DD-32832AE404B8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97049" y="3960319"/>
                      <a:ext cx="439556" cy="215444"/>
                      <a:chOff x="10241" y="3960319"/>
                      <a:chExt cx="439556" cy="215444"/>
                    </a:xfrm>
                  </p:grpSpPr>
                  <p:cxnSp>
                    <p:nvCxnSpPr>
                      <p:cNvPr id="86" name="Connecteur droit avec flèche 85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C18771F-35E3-664E-AB0D-4345B4207ADE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341797" y="4076342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94" name="Rectangle 93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673C1BF-121E-2248-92A7-A5AD02FAD446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0241" y="3960319"/>
                        <a:ext cx="357790" cy="215444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8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400</a:t>
                        </a:r>
                        <a:endPara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grpSp>
                  <p:nvGrpSpPr>
                    <p:cNvPr id="104" name="Groupe 103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13142A5-1EC6-A344-8972-7E772E8F50E2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97049" y="3811296"/>
                      <a:ext cx="439556" cy="215444"/>
                      <a:chOff x="10241" y="3811296"/>
                      <a:chExt cx="439556" cy="215444"/>
                    </a:xfrm>
                  </p:grpSpPr>
                  <p:cxnSp>
                    <p:nvCxnSpPr>
                      <p:cNvPr id="84" name="Connecteur droit avec flèche 83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FB06D35-CD4A-174C-96AE-99F70D4F2F1D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341797" y="3916851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95" name="Rectangle 94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82545AF-F3B3-964F-95D3-07CCC6C9E47A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0241" y="3811296"/>
                        <a:ext cx="357790" cy="215444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8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600</a:t>
                        </a:r>
                        <a:endPara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grpSp>
                  <p:nvGrpSpPr>
                    <p:cNvPr id="105" name="Groupe 104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6F8AC73-B6FB-C84B-8196-40DC67524D14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97049" y="3662273"/>
                      <a:ext cx="439556" cy="215444"/>
                      <a:chOff x="10241" y="3662273"/>
                      <a:chExt cx="439556" cy="215444"/>
                    </a:xfrm>
                  </p:grpSpPr>
                  <p:cxnSp>
                    <p:nvCxnSpPr>
                      <p:cNvPr id="87" name="Connecteur droit avec flèche 86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7E62717-69F5-2741-AA90-0C8000D880FE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341797" y="3785720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96" name="Rectangle 95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B729508-A379-9E4F-B47A-1BDA2AC3DF81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0241" y="3662273"/>
                        <a:ext cx="357790" cy="215444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8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800</a:t>
                        </a:r>
                        <a:endPara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grpSp>
                  <p:nvGrpSpPr>
                    <p:cNvPr id="107" name="Groupe 106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49F01BC-6D2D-A645-91B5-371C1583CA1B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68195" y="3542432"/>
                      <a:ext cx="468410" cy="215444"/>
                      <a:chOff x="-18613" y="3542432"/>
                      <a:chExt cx="468410" cy="215444"/>
                    </a:xfrm>
                  </p:grpSpPr>
                  <p:sp>
                    <p:nvSpPr>
                      <p:cNvPr id="97" name="Rectangle 96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1A10FD5-51EA-D741-9209-43111B374349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-18613" y="3542432"/>
                        <a:ext cx="415498" cy="215444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8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00</a:t>
                        </a:r>
                        <a:endPara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grpSp>
                    <p:nvGrpSpPr>
                      <p:cNvPr id="106" name="Groupe 105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0EC03EF-A2A4-FD4F-A03F-EA8D841BDDC5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311886" y="3665448"/>
                        <a:ext cx="137911" cy="49020"/>
                        <a:chOff x="311886" y="3665448"/>
                        <a:chExt cx="137911" cy="49020"/>
                      </a:xfrm>
                    </p:grpSpPr>
                    <p:cxnSp>
                      <p:nvCxnSpPr>
                        <p:cNvPr id="88" name="Connecteur droit avec flèche 87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02FCE7C-2BA0-5D44-A50F-63B8C15D6AC1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341797" y="3711293"/>
                          <a:ext cx="108000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98" name="Connecteur droit avec flèche 97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40D480A-8B57-1249-921F-A2D1605FCFF7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 flipV="1">
                          <a:off x="311886" y="3665448"/>
                          <a:ext cx="36000" cy="4902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</p:grpSp>
                <p:grpSp>
                  <p:nvGrpSpPr>
                    <p:cNvPr id="108" name="Groupe 107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D4DEC2D-7B32-8846-A57E-325F33DA4840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68195" y="3418391"/>
                      <a:ext cx="468410" cy="215444"/>
                      <a:chOff x="-18613" y="3418391"/>
                      <a:chExt cx="468410" cy="215444"/>
                    </a:xfrm>
                  </p:grpSpPr>
                  <p:cxnSp>
                    <p:nvCxnSpPr>
                      <p:cNvPr id="89" name="Connecteur droit avec flèche 88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182CF50-2AAC-0C44-8F96-7C53A9169A70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341797" y="3537628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00" name="Rectangle 99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8A6EFF0-1F32-6A4D-B22F-C0030D204134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-18613" y="3418391"/>
                        <a:ext cx="415498" cy="215444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8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500</a:t>
                        </a:r>
                        <a:endPara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grpSp>
                  <p:nvGrpSpPr>
                    <p:cNvPr id="109" name="Groupe 108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A34C940-D7B0-994F-BDE3-697D78BC28A5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68195" y="3287262"/>
                      <a:ext cx="468410" cy="215444"/>
                      <a:chOff x="-18613" y="3287262"/>
                      <a:chExt cx="468410" cy="215444"/>
                    </a:xfrm>
                  </p:grpSpPr>
                  <p:cxnSp>
                    <p:nvCxnSpPr>
                      <p:cNvPr id="90" name="Connecteur droit avec flèche 89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FB63EEB-14A7-F649-BDEC-5B8613E19E9F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341797" y="3385227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01" name="Rectangle 100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A9E65E6-35CB-9640-A6DD-1A4C08384175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-18613" y="3287262"/>
                        <a:ext cx="415498" cy="215444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8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2000</a:t>
                        </a:r>
                        <a:endPara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grpSp>
                  <p:nvGrpSpPr>
                    <p:cNvPr id="110" name="Groupe 109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AD32AB0-1A79-4C44-93FC-7653FDBA4A9C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68195" y="3192612"/>
                      <a:ext cx="468410" cy="215444"/>
                      <a:chOff x="-18613" y="3170310"/>
                      <a:chExt cx="468410" cy="215444"/>
                    </a:xfrm>
                  </p:grpSpPr>
                  <p:cxnSp>
                    <p:nvCxnSpPr>
                      <p:cNvPr id="91" name="Connecteur droit avec flèche 90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0BE07CF-D3EE-F14D-B59A-778F4E5B4F62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341797" y="3282442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02" name="Rectangle 101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2CAD58F-29D3-0F47-9498-5B463C5CD402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-18613" y="3170310"/>
                        <a:ext cx="415498" cy="215444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8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2500</a:t>
                        </a:r>
                        <a:endPara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</p:grpSp>
              <p:grpSp>
                <p:nvGrpSpPr>
                  <p:cNvPr id="24" name="Groupe 23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0FC0E91-3C81-834D-A353-CFD15B9A69CF}"/>
                      </a:ext>
                    </a:extLst>
                  </p:cNvPr>
                  <p:cNvGrpSpPr/>
                  <p:nvPr/>
                </p:nvGrpSpPr>
                <p:grpSpPr>
                  <a:xfrm>
                    <a:off x="4542883" y="2119514"/>
                    <a:ext cx="2166664" cy="2237684"/>
                    <a:chOff x="4542883" y="2119514"/>
                    <a:chExt cx="2166664" cy="2237684"/>
                  </a:xfrm>
                </p:grpSpPr>
                <p:grpSp>
                  <p:nvGrpSpPr>
                    <p:cNvPr id="46" name="Grouper 18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9BFD525-566D-004C-94FE-FFC9A4CE9802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981547" y="2119514"/>
                      <a:ext cx="1728000" cy="2237684"/>
                      <a:chOff x="2696317" y="5446914"/>
                      <a:chExt cx="1728000" cy="2237684"/>
                    </a:xfrm>
                  </p:grpSpPr>
                  <p:sp>
                    <p:nvSpPr>
                      <p:cNvPr id="47" name="TextBox 25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737525C-2F31-5D45-9A91-F66D5FCBFC83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241007" y="5446914"/>
                        <a:ext cx="841715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lIns="0" tIns="0" rIns="0" bIns="0" rtlCol="0">
                        <a:spAutoFit/>
                      </a:bodyPr>
                      <a:lstStyle/>
                      <a:p>
                        <a:pPr algn="ctr"/>
                        <a:r>
                          <a:rPr lang="en-US" sz="1200" b="1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3</a:t>
                        </a:r>
                      </a:p>
                      <a:p>
                        <a:pPr algn="ctr"/>
                        <a:r>
                          <a:rPr lang="en-US" sz="1200" b="1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(495 </a:t>
                        </a:r>
                        <a:r>
                          <a:rPr lang="en-US" sz="1200" b="1" dirty="0" err="1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bp</a:t>
                        </a:r>
                        <a:r>
                          <a:rPr lang="en-US" sz="1200" b="1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)</a:t>
                        </a:r>
                      </a:p>
                    </p:txBody>
                  </p:sp>
                  <p:sp>
                    <p:nvSpPr>
                      <p:cNvPr id="48" name="TextBox 25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C8A8474-7FA6-BA43-BEEE-CE406B51F35B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585779" y="5911779"/>
                        <a:ext cx="391930" cy="15388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lIns="0" tIns="0" rIns="0" bIns="0" rtlCol="0">
                        <a:spAutoFit/>
                      </a:bodyPr>
                      <a:lstStyle/>
                      <a:p>
                        <a:pPr algn="ctr"/>
                        <a:r>
                          <a:rPr lang="en-US" sz="1000" b="1" dirty="0" err="1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cDNA</a:t>
                        </a:r>
                        <a:endParaRPr lang="en-US" sz="1000" b="1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49" name="Parenthèse ouvrante 48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9A2672C-2398-8548-849D-353617270798}"/>
                          </a:ext>
                        </a:extLst>
                      </p:cNvPr>
                      <p:cNvSpPr/>
                      <p:nvPr/>
                    </p:nvSpPr>
                    <p:spPr>
                      <a:xfrm rot="5400000">
                        <a:off x="3747267" y="5266213"/>
                        <a:ext cx="45719" cy="1213522"/>
                      </a:xfrm>
                      <a:prstGeom prst="leftBracket">
                        <a:avLst/>
                      </a:prstGeom>
                      <a:ln w="1905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fr-FR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0" name="TextBox 25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914316E-8A81-BB47-811A-6ECC27035E70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167956" y="5911779"/>
                        <a:ext cx="417823" cy="15388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lIns="0" tIns="0" rIns="0" bIns="0" rtlCol="0">
                        <a:spAutoFit/>
                      </a:bodyPr>
                      <a:lstStyle/>
                      <a:p>
                        <a:pPr algn="ctr"/>
                        <a:r>
                          <a:rPr lang="en-US" sz="1000" b="1" dirty="0" err="1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gDNA</a:t>
                        </a:r>
                        <a:endParaRPr lang="en-US" sz="1000" b="1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51" name="TextBox 25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23E93E6-716B-2E46-BF8A-0663FF0F543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034641" y="5911779"/>
                        <a:ext cx="299285" cy="15388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lIns="0" tIns="0" rIns="0" bIns="0" rtlCol="0">
                        <a:spAutoFit/>
                      </a:bodyPr>
                      <a:lstStyle/>
                      <a:p>
                        <a:pPr algn="ctr"/>
                        <a:r>
                          <a:rPr lang="en-US" sz="1000" b="1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RNA</a:t>
                        </a:r>
                      </a:p>
                    </p:txBody>
                  </p:sp>
                  <p:pic>
                    <p:nvPicPr>
                      <p:cNvPr id="52" name="Image 51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62D100F-00B8-3447-B389-86421943DD52}"/>
                          </a:ext>
                        </a:extLst>
                      </p:cNvPr>
                      <p:cNvPicPr>
                        <a:picLocks/>
                      </p:cNvPicPr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696317" y="6100598"/>
                        <a:ext cx="1728000" cy="1584000"/>
                      </a:xfrm>
                      <a:prstGeom prst="rect">
                        <a:avLst/>
                      </a:prstGeom>
                    </p:spPr>
                  </p:pic>
                </p:grpSp>
                <p:grpSp>
                  <p:nvGrpSpPr>
                    <p:cNvPr id="111" name="Groupe 110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D906B7D-E238-F74E-9A27-F42507CFDC05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542883" y="3959792"/>
                      <a:ext cx="439556" cy="215444"/>
                      <a:chOff x="10241" y="3960319"/>
                      <a:chExt cx="439556" cy="215444"/>
                    </a:xfrm>
                  </p:grpSpPr>
                  <p:cxnSp>
                    <p:nvCxnSpPr>
                      <p:cNvPr id="112" name="Connecteur droit avec flèche 111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4B0C16E-7815-AA41-A3D3-9B046BB1126D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341797" y="4076342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13" name="Rectangle 112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578775C-B4FA-F542-88F5-0A4ACA9DEF99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0241" y="3960319"/>
                        <a:ext cx="357790" cy="215444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8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400</a:t>
                        </a:r>
                        <a:endPara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grpSp>
                  <p:nvGrpSpPr>
                    <p:cNvPr id="114" name="Groupe 113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6F721F6-862C-2843-B659-FA40C46A0320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542883" y="3810769"/>
                      <a:ext cx="439556" cy="215444"/>
                      <a:chOff x="10241" y="3811296"/>
                      <a:chExt cx="439556" cy="215444"/>
                    </a:xfrm>
                  </p:grpSpPr>
                  <p:cxnSp>
                    <p:nvCxnSpPr>
                      <p:cNvPr id="115" name="Connecteur droit avec flèche 114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EFD55DF-0750-254C-BF98-120169DA656A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341797" y="3916851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16" name="Rectangle 115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E2FBB57-C3B7-CB4C-996E-C46B007815C8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0241" y="3811296"/>
                        <a:ext cx="357790" cy="215444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8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600</a:t>
                        </a:r>
                        <a:endPara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grpSp>
                  <p:nvGrpSpPr>
                    <p:cNvPr id="117" name="Groupe 116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82A3C84-5BD8-8B42-AFDB-3B33315E859E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542883" y="3661746"/>
                      <a:ext cx="439556" cy="215444"/>
                      <a:chOff x="10241" y="3662273"/>
                      <a:chExt cx="439556" cy="215444"/>
                    </a:xfrm>
                  </p:grpSpPr>
                  <p:cxnSp>
                    <p:nvCxnSpPr>
                      <p:cNvPr id="118" name="Connecteur droit avec flèche 117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A42EF93-486F-EA40-A878-163196815111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341797" y="3785720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19" name="Rectangle 118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39E2807-EB49-8E4E-A17D-424D141F374F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10241" y="3662273"/>
                        <a:ext cx="357790" cy="215444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8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800</a:t>
                        </a:r>
                        <a:endPara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</p:grpSp>
              <p:grpSp>
                <p:nvGrpSpPr>
                  <p:cNvPr id="3" name="Groupe 2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5628300-BBB8-7A4C-A119-155A2CD3D1D3}"/>
                      </a:ext>
                    </a:extLst>
                  </p:cNvPr>
                  <p:cNvGrpSpPr/>
                  <p:nvPr/>
                </p:nvGrpSpPr>
                <p:grpSpPr>
                  <a:xfrm>
                    <a:off x="2274003" y="2115080"/>
                    <a:ext cx="2184685" cy="2242118"/>
                    <a:chOff x="2274003" y="2115080"/>
                    <a:chExt cx="2184685" cy="2242118"/>
                  </a:xfrm>
                </p:grpSpPr>
                <p:grpSp>
                  <p:nvGrpSpPr>
                    <p:cNvPr id="54" name="Groupe 53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1D9CB56-97B2-1341-90ED-74042A4F7356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730688" y="2115080"/>
                      <a:ext cx="1728000" cy="2242118"/>
                      <a:chOff x="2528009" y="3245380"/>
                      <a:chExt cx="1728000" cy="2242118"/>
                    </a:xfrm>
                  </p:grpSpPr>
                  <p:pic>
                    <p:nvPicPr>
                      <p:cNvPr id="40" name="Image 39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8685837-9389-BC4D-ADCE-6FB0203C29C8}"/>
                          </a:ext>
                        </a:extLst>
                      </p:cNvPr>
                      <p:cNvPicPr>
                        <a:picLocks/>
                      </p:cNvPicPr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528009" y="3903498"/>
                        <a:ext cx="1728000" cy="1584000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41" name="TextBox 25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AC849BB-03DE-EA47-9DB6-3F02FCD2D3C5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050334" y="3727363"/>
                        <a:ext cx="417823" cy="15388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lIns="0" tIns="0" rIns="0" bIns="0" rtlCol="0">
                        <a:spAutoFit/>
                      </a:bodyPr>
                      <a:lstStyle/>
                      <a:p>
                        <a:pPr algn="ctr"/>
                        <a:r>
                          <a:rPr lang="en-US" sz="1000" b="1" dirty="0" err="1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gDNA</a:t>
                        </a:r>
                        <a:endParaRPr lang="en-US" sz="1000" b="1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42" name="TextBox 25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69567DD-DBCC-9D44-BF39-5516CD4C7B84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240716" y="3245380"/>
                        <a:ext cx="841715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lIns="0" tIns="0" rIns="0" bIns="0" rtlCol="0">
                        <a:spAutoFit/>
                      </a:bodyPr>
                      <a:lstStyle/>
                      <a:p>
                        <a:pPr algn="ctr"/>
                        <a:r>
                          <a:rPr lang="en-US" sz="1200" b="1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2</a:t>
                        </a:r>
                      </a:p>
                      <a:p>
                        <a:pPr algn="ctr"/>
                        <a:r>
                          <a:rPr lang="en-US" sz="1200" b="1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(155 </a:t>
                        </a:r>
                        <a:r>
                          <a:rPr lang="en-US" sz="1200" b="1" dirty="0" err="1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bp</a:t>
                        </a:r>
                        <a:r>
                          <a:rPr lang="en-US" sz="1200" b="1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)</a:t>
                        </a:r>
                      </a:p>
                    </p:txBody>
                  </p:sp>
                  <p:sp>
                    <p:nvSpPr>
                      <p:cNvPr id="43" name="TextBox 25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18B106F-2378-3B4B-BE65-373BA8544606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489589" y="3727363"/>
                        <a:ext cx="391930" cy="15388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lIns="0" tIns="0" rIns="0" bIns="0" rtlCol="0">
                        <a:spAutoFit/>
                      </a:bodyPr>
                      <a:lstStyle/>
                      <a:p>
                        <a:pPr algn="ctr"/>
                        <a:r>
                          <a:rPr lang="en-US" sz="1000" b="1" dirty="0" err="1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cDNA</a:t>
                        </a:r>
                        <a:endParaRPr lang="en-US" sz="1000" b="1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44" name="TextBox 25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0B8109B-A44C-9E4E-BEA3-F24B3E6F10CC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933953" y="3727363"/>
                        <a:ext cx="299285" cy="15388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lIns="0" tIns="0" rIns="0" bIns="0" rtlCol="0">
                        <a:spAutoFit/>
                      </a:bodyPr>
                      <a:lstStyle/>
                      <a:p>
                        <a:pPr algn="ctr"/>
                        <a:r>
                          <a:rPr lang="en-US" sz="1000" b="1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RNA</a:t>
                        </a:r>
                      </a:p>
                    </p:txBody>
                  </p:sp>
                  <p:sp>
                    <p:nvSpPr>
                      <p:cNvPr id="45" name="Parenthèse ouvrante 44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E9A4B21-80B9-704D-B380-8F3B5B969263}"/>
                          </a:ext>
                        </a:extLst>
                      </p:cNvPr>
                      <p:cNvSpPr/>
                      <p:nvPr/>
                    </p:nvSpPr>
                    <p:spPr>
                      <a:xfrm rot="5400000">
                        <a:off x="3622869" y="3061159"/>
                        <a:ext cx="45719" cy="1220561"/>
                      </a:xfrm>
                      <a:prstGeom prst="leftBracket">
                        <a:avLst/>
                      </a:prstGeom>
                      <a:ln w="19050" cmpd="sng">
                        <a:solidFill>
                          <a:srgbClr val="000000"/>
                        </a:solidFill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fr-FR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grpSp>
                  <p:nvGrpSpPr>
                    <p:cNvPr id="153" name="Groupe 152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98BE2D5-AF34-7143-A387-26788EDE0ED5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274003" y="3199519"/>
                      <a:ext cx="455180" cy="215444"/>
                      <a:chOff x="2274003" y="3199519"/>
                      <a:chExt cx="455180" cy="215444"/>
                    </a:xfrm>
                  </p:grpSpPr>
                  <p:cxnSp>
                    <p:nvCxnSpPr>
                      <p:cNvPr id="135" name="Connecteur droit avec flèche 134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D3AC14C-205E-E74B-B782-6327BE700C39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2621183" y="3318756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36" name="Rectangle 135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88F33B9-24C0-524C-97D3-E0E5B525F49F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274003" y="3199519"/>
                        <a:ext cx="415498" cy="215444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8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00</a:t>
                        </a:r>
                        <a:endPara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grpSp>
                  <p:nvGrpSpPr>
                    <p:cNvPr id="152" name="Groupe 151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17B3971-6403-3E48-BE40-4B5ADBBBAA9E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302857" y="3441425"/>
                      <a:ext cx="426326" cy="215444"/>
                      <a:chOff x="2302857" y="3441425"/>
                      <a:chExt cx="426326" cy="215444"/>
                    </a:xfrm>
                  </p:grpSpPr>
                  <p:cxnSp>
                    <p:nvCxnSpPr>
                      <p:cNvPr id="138" name="Connecteur droit avec flèche 137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3A71DDE-DFB1-7448-AC71-F62A815E61B2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2621183" y="3560662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39" name="Rectangle 138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6E52A42-E30E-2F48-AA85-5A0DE2D7111E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302857" y="3441425"/>
                        <a:ext cx="357790" cy="215444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8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600</a:t>
                        </a:r>
                        <a:endPara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grpSp>
                  <p:nvGrpSpPr>
                    <p:cNvPr id="150" name="Groupe 149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DB186C2-831F-884B-A109-2D731D33C64B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302857" y="3805104"/>
                      <a:ext cx="426326" cy="215444"/>
                      <a:chOff x="2302857" y="3805104"/>
                      <a:chExt cx="426326" cy="215444"/>
                    </a:xfrm>
                  </p:grpSpPr>
                  <p:cxnSp>
                    <p:nvCxnSpPr>
                      <p:cNvPr id="141" name="Connecteur droit avec flèche 140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586A75A-7043-5541-929F-F4949A337AC5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2621183" y="3924341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42" name="Rectangle 141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8C9B32E-833C-9B46-B95C-7B61FE22BE20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302857" y="3805104"/>
                        <a:ext cx="357790" cy="215444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8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200</a:t>
                        </a:r>
                        <a:endPara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grpSp>
                  <p:nvGrpSpPr>
                    <p:cNvPr id="149" name="Groupe 148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26D4CEA-3FBA-FF42-AF82-DBF4ABA8BEBF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302857" y="3926947"/>
                      <a:ext cx="426326" cy="215444"/>
                      <a:chOff x="2302857" y="3926947"/>
                      <a:chExt cx="426326" cy="215444"/>
                    </a:xfrm>
                  </p:grpSpPr>
                  <p:cxnSp>
                    <p:nvCxnSpPr>
                      <p:cNvPr id="144" name="Connecteur droit avec flèche 143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83A0B3F-81AF-5A46-9804-C5A4DDD7DAEA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2621183" y="4046184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45" name="Rectangle 144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165F320-2BD2-5E48-8D34-1A2E4C058F68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302857" y="3926947"/>
                        <a:ext cx="357790" cy="215444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8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0</a:t>
                        </a:r>
                        <a:endPara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grpSp>
                  <p:nvGrpSpPr>
                    <p:cNvPr id="151" name="Groupe 150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B11EF27-D9F5-A947-9323-BF5593C2319D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302857" y="3587944"/>
                      <a:ext cx="426326" cy="215444"/>
                      <a:chOff x="2302857" y="3587944"/>
                      <a:chExt cx="426326" cy="215444"/>
                    </a:xfrm>
                  </p:grpSpPr>
                  <p:cxnSp>
                    <p:nvCxnSpPr>
                      <p:cNvPr id="147" name="Connecteur droit avec flèche 146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A379241-B82D-8940-BC66-F9EB5A3BCEA3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2621183" y="3707181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48" name="Rectangle 147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A25CAA3-4101-3B4E-B023-EE1D70C802C5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302857" y="3587944"/>
                        <a:ext cx="357790" cy="215444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800" dirty="0">
                            <a:solidFill>
                              <a:srgbClr val="000000"/>
                            </a:solidFill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400</a:t>
                        </a:r>
                        <a:endParaRPr lang="fr-FR" sz="8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</p:grpSp>
            </p:grpSp>
            <p:sp>
              <p:nvSpPr>
                <p:cNvPr id="146" name="ZoneTexte 145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2361157-DA3A-D24D-9FF5-ADEA66ABE0FE}"/>
                    </a:ext>
                  </a:extLst>
                </p:cNvPr>
                <p:cNvSpPr txBox="1"/>
                <p:nvPr/>
              </p:nvSpPr>
              <p:spPr>
                <a:xfrm>
                  <a:off x="299907" y="2134750"/>
                  <a:ext cx="332142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1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</a:p>
              </p:txBody>
            </p:sp>
          </p:grpSp>
          <p:sp>
            <p:nvSpPr>
              <p:cNvPr id="157" name="ZoneTexte 156">
                <a:extLst>
                  <a:ext uri="{FF2B5EF4-FFF2-40B4-BE49-F238E27FC236}">
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44F99E9-19A0-3F47-801F-453E7E02C26E}"/>
                  </a:ext>
                </a:extLst>
              </p:cNvPr>
              <p:cNvSpPr txBox="1"/>
              <p:nvPr/>
            </p:nvSpPr>
            <p:spPr>
              <a:xfrm>
                <a:off x="247001" y="8464671"/>
                <a:ext cx="642195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1 Fig. </a:t>
                </a:r>
                <a:r>
                  <a:rPr lang="en-GB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ncrease of the </a:t>
                </a:r>
                <a:r>
                  <a:rPr lang="en-US" sz="1100" b="1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nk-katE</a:t>
                </a:r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operon expression </a:t>
                </a:r>
                <a:r>
                  <a:rPr lang="en-GB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upon exposure to sublethal dose of H</a:t>
                </a:r>
                <a:r>
                  <a:rPr lang="en-GB" sz="11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GB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O</a:t>
                </a:r>
                <a:r>
                  <a:rPr lang="en-GB" sz="11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.</a:t>
                </a:r>
                <a:endParaRPr lang="fr-FR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67" name="Groupe 66">
                <a:extLst>
                  <a:ext uri="{FF2B5EF4-FFF2-40B4-BE49-F238E27FC236}">
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E0F06A1-AE92-9641-BCAD-EA00DBD473A3}"/>
                  </a:ext>
                </a:extLst>
              </p:cNvPr>
              <p:cNvGrpSpPr/>
              <p:nvPr/>
            </p:nvGrpSpPr>
            <p:grpSpPr>
              <a:xfrm>
                <a:off x="295960" y="4623608"/>
                <a:ext cx="5816270" cy="3537737"/>
                <a:chOff x="295960" y="4623608"/>
                <a:chExt cx="5816270" cy="3537737"/>
              </a:xfrm>
            </p:grpSpPr>
            <p:pic>
              <p:nvPicPr>
                <p:cNvPr id="140" name="Image 139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81C2567-7B48-3F42-92BE-065EA1D0290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/>
                <a:srcRect r="4970" b="6584"/>
                <a:stretch/>
              </p:blipFill>
              <p:spPr>
                <a:xfrm>
                  <a:off x="1227633" y="4623608"/>
                  <a:ext cx="4217015" cy="2935078"/>
                </a:xfrm>
                <a:prstGeom prst="rect">
                  <a:avLst/>
                </a:prstGeom>
              </p:spPr>
            </p:pic>
            <p:sp>
              <p:nvSpPr>
                <p:cNvPr id="56" name="ZoneTexte 55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FCA4F7F-36C6-6A48-BAEB-C294272119D3}"/>
                    </a:ext>
                  </a:extLst>
                </p:cNvPr>
                <p:cNvSpPr txBox="1"/>
                <p:nvPr/>
              </p:nvSpPr>
              <p:spPr>
                <a:xfrm rot="16200000">
                  <a:off x="231890" y="5971280"/>
                  <a:ext cx="174962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ene expression </a:t>
                  </a:r>
                  <a:r>
                    <a:rPr lang="fr-FR" sz="12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fold</a:t>
                  </a:r>
                  <a:endParaRPr lang="fr-FR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1" name="ZoneTexte 70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E7025E2-782F-ED49-9BA1-AE2ACE05ED28}"/>
                    </a:ext>
                  </a:extLst>
                </p:cNvPr>
                <p:cNvSpPr txBox="1"/>
                <p:nvPr/>
              </p:nvSpPr>
              <p:spPr>
                <a:xfrm>
                  <a:off x="5207600" y="7472751"/>
                  <a:ext cx="90463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 </a:t>
                  </a:r>
                  <a:r>
                    <a:rPr lang="fr-FR" sz="10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μM</a:t>
                  </a:r>
                  <a:r>
                    <a:rPr lang="fr-F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H</a:t>
                  </a:r>
                  <a:r>
                    <a:rPr lang="fr-FR" sz="1000" b="1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r>
                    <a:rPr lang="fr-FR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O</a:t>
                  </a:r>
                  <a:r>
                    <a:rPr lang="fr-FR" sz="1000" b="1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</a:p>
              </p:txBody>
            </p:sp>
            <p:sp>
              <p:nvSpPr>
                <p:cNvPr id="154" name="ZoneTexte 153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79AD796-66E6-9D4C-9284-65E2C9039D6D}"/>
                    </a:ext>
                  </a:extLst>
                </p:cNvPr>
                <p:cNvSpPr txBox="1"/>
                <p:nvPr/>
              </p:nvSpPr>
              <p:spPr>
                <a:xfrm>
                  <a:off x="295960" y="4961821"/>
                  <a:ext cx="332142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1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</a:p>
              </p:txBody>
            </p:sp>
            <p:grpSp>
              <p:nvGrpSpPr>
                <p:cNvPr id="63" name="Groupe 62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E0728AE-35F5-7A4B-8806-D5BE3F975F6D}"/>
                    </a:ext>
                  </a:extLst>
                </p:cNvPr>
                <p:cNvGrpSpPr/>
                <p:nvPr/>
              </p:nvGrpSpPr>
              <p:grpSpPr>
                <a:xfrm>
                  <a:off x="1531725" y="7441973"/>
                  <a:ext cx="992579" cy="719372"/>
                  <a:chOff x="1531725" y="7441973"/>
                  <a:chExt cx="992579" cy="719372"/>
                </a:xfrm>
              </p:grpSpPr>
              <p:sp>
                <p:nvSpPr>
                  <p:cNvPr id="57" name="ZoneTexte 56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B2F65BD-C3EB-D748-9F1F-0EC7DBD6F5F2}"/>
                      </a:ext>
                    </a:extLst>
                  </p:cNvPr>
                  <p:cNvSpPr txBox="1"/>
                  <p:nvPr/>
                </p:nvSpPr>
                <p:spPr>
                  <a:xfrm>
                    <a:off x="1531725" y="7761235"/>
                    <a:ext cx="992579" cy="4001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fr-FR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IMLP_10140</a:t>
                    </a:r>
                  </a:p>
                  <a:p>
                    <a:pPr algn="ctr"/>
                    <a:r>
                      <a:rPr lang="fr-FR" sz="10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is</a:t>
                    </a:r>
                    <a:r>
                      <a:rPr lang="fr-FR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Kinase</a:t>
                    </a:r>
                  </a:p>
                </p:txBody>
              </p:sp>
              <p:grpSp>
                <p:nvGrpSpPr>
                  <p:cNvPr id="28" name="Groupe 27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591AC65-A7E5-C644-A933-46D7C3A46390}"/>
                      </a:ext>
                    </a:extLst>
                  </p:cNvPr>
                  <p:cNvGrpSpPr/>
                  <p:nvPr/>
                </p:nvGrpSpPr>
                <p:grpSpPr>
                  <a:xfrm>
                    <a:off x="1614629" y="7441973"/>
                    <a:ext cx="816574" cy="307777"/>
                    <a:chOff x="1614629" y="7441973"/>
                    <a:chExt cx="816574" cy="307777"/>
                  </a:xfrm>
                </p:grpSpPr>
                <p:sp>
                  <p:nvSpPr>
                    <p:cNvPr id="72" name="ZoneTexte 71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89DE0AD-759B-254B-AF5B-F00682AA276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614629" y="7441973"/>
                      <a:ext cx="248786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fr-FR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p:txBody>
                </p:sp>
                <p:sp>
                  <p:nvSpPr>
                    <p:cNvPr id="73" name="ZoneTexte 72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4699E7E-DB85-3843-9388-2887CFE9276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881871" y="7441973"/>
                      <a:ext cx="289512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fr-FR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p:txBody>
                </p:sp>
                <p:sp>
                  <p:nvSpPr>
                    <p:cNvPr id="74" name="ZoneTexte 73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4FCE19A-BBA4-0A4A-9ABD-6165A2D6563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141691" y="7441973"/>
                      <a:ext cx="289512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fr-FR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p:txBody>
                </p:sp>
              </p:grpSp>
              <p:sp>
                <p:nvSpPr>
                  <p:cNvPr id="20" name="Parenthèse ouvrante 19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826E219-69DA-3B40-9AC5-E928D35764ED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1979712" y="7220060"/>
                    <a:ext cx="99308" cy="828000"/>
                  </a:xfrm>
                  <a:prstGeom prst="leftBracket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</p:grpSp>
            <p:grpSp>
              <p:nvGrpSpPr>
                <p:cNvPr id="64" name="Groupe 63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DD6E859-F13B-3748-9B33-0C9038A2BC19}"/>
                    </a:ext>
                  </a:extLst>
                </p:cNvPr>
                <p:cNvGrpSpPr/>
                <p:nvPr/>
              </p:nvGrpSpPr>
              <p:grpSpPr>
                <a:xfrm>
                  <a:off x="2465119" y="7441973"/>
                  <a:ext cx="992579" cy="719372"/>
                  <a:chOff x="2465119" y="7441973"/>
                  <a:chExt cx="992579" cy="719372"/>
                </a:xfrm>
              </p:grpSpPr>
              <p:sp>
                <p:nvSpPr>
                  <p:cNvPr id="58" name="ZoneTexte 57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E12B968-8E40-4D4A-A2C5-33484DFF37EA}"/>
                      </a:ext>
                    </a:extLst>
                  </p:cNvPr>
                  <p:cNvSpPr txBox="1"/>
                  <p:nvPr/>
                </p:nvSpPr>
                <p:spPr>
                  <a:xfrm>
                    <a:off x="2465119" y="7761235"/>
                    <a:ext cx="992579" cy="4001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fr-FR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IMLP_10145</a:t>
                    </a:r>
                  </a:p>
                  <a:p>
                    <a:pPr algn="ctr"/>
                    <a:r>
                      <a:rPr lang="fr-FR" sz="1000" b="1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atE</a:t>
                    </a:r>
                    <a:endParaRPr lang="fr-FR" sz="1000" b="1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grpSp>
                <p:nvGrpSpPr>
                  <p:cNvPr id="55" name="Groupe 5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2C71F2E-5E1B-E042-BC52-0E8340D78D71}"/>
                      </a:ext>
                    </a:extLst>
                  </p:cNvPr>
                  <p:cNvGrpSpPr/>
                  <p:nvPr/>
                </p:nvGrpSpPr>
                <p:grpSpPr>
                  <a:xfrm>
                    <a:off x="2573412" y="7441973"/>
                    <a:ext cx="793843" cy="307777"/>
                    <a:chOff x="2578578" y="7441973"/>
                    <a:chExt cx="793843" cy="307777"/>
                  </a:xfrm>
                </p:grpSpPr>
                <p:sp>
                  <p:nvSpPr>
                    <p:cNvPr id="75" name="ZoneTexte 74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71A9589-1FC2-494A-BE2E-A31AF847F78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578578" y="7441973"/>
                      <a:ext cx="248786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fr-FR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p:txBody>
                </p:sp>
                <p:sp>
                  <p:nvSpPr>
                    <p:cNvPr id="76" name="ZoneTexte 7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B6F4F5E-99D4-584E-83B8-EA1F6CD2364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830709" y="7441973"/>
                      <a:ext cx="289512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fr-FR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p:txBody>
                </p:sp>
                <p:sp>
                  <p:nvSpPr>
                    <p:cNvPr id="77" name="ZoneTexte 76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D9509B0-7EA8-F241-800D-948D7468058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082909" y="7441973"/>
                      <a:ext cx="289512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fr-FR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p:txBody>
                </p:sp>
              </p:grpSp>
              <p:sp>
                <p:nvSpPr>
                  <p:cNvPr id="158" name="Parenthèse ouvrante 157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5CA4A51-79E6-4442-8A92-D580EC474F66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2913990" y="7220060"/>
                    <a:ext cx="99308" cy="828000"/>
                  </a:xfrm>
                  <a:prstGeom prst="leftBracket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</p:grpSp>
            <p:grpSp>
              <p:nvGrpSpPr>
                <p:cNvPr id="65" name="Groupe 64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8E7D8F3-1D83-9B4A-9510-CD6E7409E1B0}"/>
                    </a:ext>
                  </a:extLst>
                </p:cNvPr>
                <p:cNvGrpSpPr/>
                <p:nvPr/>
              </p:nvGrpSpPr>
              <p:grpSpPr>
                <a:xfrm>
                  <a:off x="3428324" y="7441973"/>
                  <a:ext cx="992579" cy="719372"/>
                  <a:chOff x="3428324" y="7441973"/>
                  <a:chExt cx="992579" cy="719372"/>
                </a:xfrm>
              </p:grpSpPr>
              <p:sp>
                <p:nvSpPr>
                  <p:cNvPr id="59" name="ZoneTexte 58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810C98C-59D2-E04B-9280-CAE86AAB307D}"/>
                      </a:ext>
                    </a:extLst>
                  </p:cNvPr>
                  <p:cNvSpPr txBox="1"/>
                  <p:nvPr/>
                </p:nvSpPr>
                <p:spPr>
                  <a:xfrm>
                    <a:off x="3428324" y="7761235"/>
                    <a:ext cx="992579" cy="4001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fr-FR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IMLP_10150</a:t>
                    </a:r>
                  </a:p>
                  <a:p>
                    <a:pPr algn="ctr"/>
                    <a:r>
                      <a:rPr lang="fr-FR" sz="1000" b="1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nk</a:t>
                    </a:r>
                    <a:endParaRPr lang="fr-FR" sz="1000" b="1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grpSp>
                <p:nvGrpSpPr>
                  <p:cNvPr id="61" name="Groupe 60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B9BA7DC-5CD3-5843-B3D1-3694C87AEAA2}"/>
                      </a:ext>
                    </a:extLst>
                  </p:cNvPr>
                  <p:cNvGrpSpPr/>
                  <p:nvPr/>
                </p:nvGrpSpPr>
                <p:grpSpPr>
                  <a:xfrm>
                    <a:off x="3526332" y="7441973"/>
                    <a:ext cx="796640" cy="307777"/>
                    <a:chOff x="3526332" y="7441973"/>
                    <a:chExt cx="796640" cy="307777"/>
                  </a:xfrm>
                </p:grpSpPr>
                <p:sp>
                  <p:nvSpPr>
                    <p:cNvPr id="78" name="ZoneTexte 77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A8AA1DC-56E3-D049-939E-F52E6672E4D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526332" y="7441973"/>
                      <a:ext cx="248786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fr-FR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p:txBody>
                </p:sp>
                <p:sp>
                  <p:nvSpPr>
                    <p:cNvPr id="79" name="ZoneTexte 78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3A3A17A-AC91-4B4B-AE87-ED4BBCA33A2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765891" y="7441973"/>
                      <a:ext cx="289512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fr-FR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p:txBody>
                </p:sp>
                <p:sp>
                  <p:nvSpPr>
                    <p:cNvPr id="80" name="ZoneTexte 79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D756B3F-18CA-704A-9075-51BEC469E83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033460" y="7441973"/>
                      <a:ext cx="289512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fr-FR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p:txBody>
                </p:sp>
              </p:grpSp>
              <p:sp>
                <p:nvSpPr>
                  <p:cNvPr id="159" name="Parenthèse ouvrante 158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E6EFE56-A132-7E43-A21A-90D42856E296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3873626" y="7220060"/>
                    <a:ext cx="99308" cy="828000"/>
                  </a:xfrm>
                  <a:prstGeom prst="leftBracket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</p:grpSp>
            <p:grpSp>
              <p:nvGrpSpPr>
                <p:cNvPr id="66" name="Groupe 65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110DBD6-359F-5642-B636-8A0BCADEB18E}"/>
                    </a:ext>
                  </a:extLst>
                </p:cNvPr>
                <p:cNvGrpSpPr/>
                <p:nvPr/>
              </p:nvGrpSpPr>
              <p:grpSpPr>
                <a:xfrm>
                  <a:off x="4371317" y="7441973"/>
                  <a:ext cx="992579" cy="719372"/>
                  <a:chOff x="4371317" y="7441973"/>
                  <a:chExt cx="992579" cy="719372"/>
                </a:xfrm>
              </p:grpSpPr>
              <p:sp>
                <p:nvSpPr>
                  <p:cNvPr id="60" name="ZoneTexte 59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BD37392-116B-7946-835A-9CBDBBCA11B0}"/>
                      </a:ext>
                    </a:extLst>
                  </p:cNvPr>
                  <p:cNvSpPr txBox="1"/>
                  <p:nvPr/>
                </p:nvSpPr>
                <p:spPr>
                  <a:xfrm>
                    <a:off x="4371317" y="7761235"/>
                    <a:ext cx="992579" cy="4001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fr-FR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IMLP_10155</a:t>
                    </a:r>
                  </a:p>
                  <a:p>
                    <a:pPr algn="ctr"/>
                    <a:r>
                      <a:rPr lang="fr-FR" sz="1000" b="1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erR</a:t>
                    </a:r>
                    <a:endParaRPr lang="fr-FR" sz="1000" b="1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grpSp>
                <p:nvGrpSpPr>
                  <p:cNvPr id="62" name="Groupe 61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E5B267E-25C8-2B46-989C-E9593A794798}"/>
                      </a:ext>
                    </a:extLst>
                  </p:cNvPr>
                  <p:cNvGrpSpPr/>
                  <p:nvPr/>
                </p:nvGrpSpPr>
                <p:grpSpPr>
                  <a:xfrm>
                    <a:off x="4476633" y="7441973"/>
                    <a:ext cx="809245" cy="307777"/>
                    <a:chOff x="4476633" y="7441973"/>
                    <a:chExt cx="809245" cy="307777"/>
                  </a:xfrm>
                </p:grpSpPr>
                <p:sp>
                  <p:nvSpPr>
                    <p:cNvPr id="81" name="ZoneTexte 80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F89F9B2-B041-B748-ABFC-ACB86729430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476633" y="7441973"/>
                      <a:ext cx="248786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fr-FR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p:txBody>
                </p:sp>
                <p:sp>
                  <p:nvSpPr>
                    <p:cNvPr id="82" name="ZoneTexte 81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31A3657-82A9-9A42-A382-ABECC7481EC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718878" y="7441973"/>
                      <a:ext cx="289512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fr-FR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p:txBody>
                </p:sp>
                <p:sp>
                  <p:nvSpPr>
                    <p:cNvPr id="83" name="ZoneTexte 82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78FA6C6-67AD-6647-AB6D-F598D123D86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996366" y="7441973"/>
                      <a:ext cx="289512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fr-FR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p:txBody>
                </p:sp>
              </p:grpSp>
              <p:sp>
                <p:nvSpPr>
                  <p:cNvPr id="160" name="Parenthèse ouvrante 159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C868713-2863-994B-BE9C-52EFA90EFC64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4821571" y="7217116"/>
                    <a:ext cx="99308" cy="828000"/>
                  </a:xfrm>
                  <a:prstGeom prst="leftBracket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</p:grpSp>
          </p:grpSp>
        </p:grpSp>
      </p:grp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37534219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a="http://schemas.openxmlformats.org/drawingml/2006/main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1</TotalTime>
  <Words>120</Words>
  <Application>Microsoft Macintosh PowerPoint</Application>
  <PresentationFormat>Présentation à l'écran (4:3)</PresentationFormat>
  <Paragraphs>80</Paragraphs>
  <Slides>1</Slides>
  <Notes>0</Notes>
  <HiddenSlides>0</HiddenSlides>
  <MMClips>0</MMClips>
  <ScaleCrop>false</ScaleCrop>
  <HeadingPairs>
    <vt:vector size="4" baseType="variant">
      <vt:variant>
        <vt:lpstr>Modèle de conception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icrosoft Office User</dc:creator>
  <cp:lastModifiedBy>nadia benaroudj</cp:lastModifiedBy>
  <cp:revision>15</cp:revision>
  <cp:lastPrinted>2020-03-17T19:01:00Z</cp:lastPrinted>
  <dcterms:created xsi:type="dcterms:W3CDTF">2020-04-03T11:55:50Z</dcterms:created>
  <dcterms:modified xsi:type="dcterms:W3CDTF">2020-04-03T11:56:53Z</dcterms:modified>
</cp:coreProperties>
</file>